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344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38375654119628"/>
          <c:y val="0.19203488408585209"/>
          <c:w val="0.80163694303324295"/>
          <c:h val="0.63527665146669765"/>
        </c:manualLayout>
      </c:layout>
      <c:scatterChart>
        <c:scatterStyle val="lineMarker"/>
        <c:varyColors val="0"/>
        <c:ser>
          <c:idx val="0"/>
          <c:order val="0"/>
          <c:tx>
            <c:strRef>
              <c:f>'p201-plots'!$B$1</c:f>
              <c:strCache>
                <c:ptCount val="1"/>
                <c:pt idx="0">
                  <c:v>Comparisons - age (after removing the first 5 years of FU) 70-79</c:v>
                </c:pt>
              </c:strCache>
            </c:strRef>
          </c:tx>
          <c:spPr>
            <a:ln w="28575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B$2:$B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65999999999999</c:v>
                </c:pt>
                <c:pt idx="3">
                  <c:v>0.99965999999999999</c:v>
                </c:pt>
                <c:pt idx="4">
                  <c:v>0.99744999999999995</c:v>
                </c:pt>
                <c:pt idx="5">
                  <c:v>0.99744999999999995</c:v>
                </c:pt>
                <c:pt idx="6">
                  <c:v>0.99143999999999999</c:v>
                </c:pt>
                <c:pt idx="7">
                  <c:v>0.99143999999999999</c:v>
                </c:pt>
                <c:pt idx="8">
                  <c:v>0.98143000000000002</c:v>
                </c:pt>
                <c:pt idx="9">
                  <c:v>0.98143000000000002</c:v>
                </c:pt>
                <c:pt idx="10">
                  <c:v>0.96750999999999998</c:v>
                </c:pt>
                <c:pt idx="11">
                  <c:v>0.96750999999999998</c:v>
                </c:pt>
                <c:pt idx="12">
                  <c:v>0.95199999999999996</c:v>
                </c:pt>
                <c:pt idx="13">
                  <c:v>0.95199999999999996</c:v>
                </c:pt>
                <c:pt idx="14">
                  <c:v>0.93288000000000004</c:v>
                </c:pt>
                <c:pt idx="15">
                  <c:v>0.93288000000000004</c:v>
                </c:pt>
                <c:pt idx="16">
                  <c:v>0.91200000000000003</c:v>
                </c:pt>
                <c:pt idx="17">
                  <c:v>0.91200000000000003</c:v>
                </c:pt>
                <c:pt idx="18">
                  <c:v>0.89056000000000002</c:v>
                </c:pt>
                <c:pt idx="19">
                  <c:v>0.89056000000000002</c:v>
                </c:pt>
                <c:pt idx="20">
                  <c:v>0.86965999999999999</c:v>
                </c:pt>
                <c:pt idx="21">
                  <c:v>0.86965999999999999</c:v>
                </c:pt>
                <c:pt idx="22">
                  <c:v>0.84555000000000002</c:v>
                </c:pt>
                <c:pt idx="23">
                  <c:v>0.84555000000000002</c:v>
                </c:pt>
                <c:pt idx="24">
                  <c:v>0.81855</c:v>
                </c:pt>
                <c:pt idx="25">
                  <c:v>0.81855</c:v>
                </c:pt>
                <c:pt idx="26">
                  <c:v>0.79986000000000002</c:v>
                </c:pt>
                <c:pt idx="27">
                  <c:v>0.79986000000000002</c:v>
                </c:pt>
                <c:pt idx="28">
                  <c:v>0.77417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B9B-431D-B932-66B0E66CA879}"/>
            </c:ext>
          </c:extLst>
        </c:ser>
        <c:ser>
          <c:idx val="1"/>
          <c:order val="1"/>
          <c:tx>
            <c:strRef>
              <c:f>'p201-plots'!$C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C$2:$C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48000000000004</c:v>
                </c:pt>
                <c:pt idx="3">
                  <c:v>0.99948000000000004</c:v>
                </c:pt>
                <c:pt idx="4">
                  <c:v>0.99697000000000002</c:v>
                </c:pt>
                <c:pt idx="5">
                  <c:v>0.99697000000000002</c:v>
                </c:pt>
                <c:pt idx="6">
                  <c:v>0.99053999999999998</c:v>
                </c:pt>
                <c:pt idx="7">
                  <c:v>0.99053999999999998</c:v>
                </c:pt>
                <c:pt idx="8">
                  <c:v>0.98009000000000002</c:v>
                </c:pt>
                <c:pt idx="9">
                  <c:v>0.98009000000000002</c:v>
                </c:pt>
                <c:pt idx="10">
                  <c:v>0.96570999999999996</c:v>
                </c:pt>
                <c:pt idx="11">
                  <c:v>0.96570999999999996</c:v>
                </c:pt>
                <c:pt idx="12">
                  <c:v>0.94977999999999996</c:v>
                </c:pt>
                <c:pt idx="13">
                  <c:v>0.94977999999999996</c:v>
                </c:pt>
                <c:pt idx="14">
                  <c:v>0.93020999999999998</c:v>
                </c:pt>
                <c:pt idx="15">
                  <c:v>0.93020999999999998</c:v>
                </c:pt>
                <c:pt idx="16">
                  <c:v>0.90888000000000002</c:v>
                </c:pt>
                <c:pt idx="17">
                  <c:v>0.90888000000000002</c:v>
                </c:pt>
                <c:pt idx="18">
                  <c:v>0.88700999999999997</c:v>
                </c:pt>
                <c:pt idx="19">
                  <c:v>0.88700999999999997</c:v>
                </c:pt>
                <c:pt idx="20">
                  <c:v>0.86565000000000003</c:v>
                </c:pt>
                <c:pt idx="21">
                  <c:v>0.86565000000000003</c:v>
                </c:pt>
                <c:pt idx="22">
                  <c:v>0.84084999999999999</c:v>
                </c:pt>
                <c:pt idx="23">
                  <c:v>0.84084999999999999</c:v>
                </c:pt>
                <c:pt idx="24">
                  <c:v>0.81257000000000001</c:v>
                </c:pt>
                <c:pt idx="25">
                  <c:v>0.81257000000000001</c:v>
                </c:pt>
                <c:pt idx="26">
                  <c:v>0.79159999999999997</c:v>
                </c:pt>
                <c:pt idx="27">
                  <c:v>0.79159999999999997</c:v>
                </c:pt>
                <c:pt idx="28">
                  <c:v>0.756539999999999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B9B-431D-B932-66B0E66CA879}"/>
            </c:ext>
          </c:extLst>
        </c:ser>
        <c:ser>
          <c:idx val="2"/>
          <c:order val="2"/>
          <c:tx>
            <c:strRef>
              <c:f>'p201-plots'!$D$1</c:f>
              <c:strCache>
                <c:ptCount val="1"/>
              </c:strCache>
            </c:strRef>
          </c:tx>
          <c:spPr>
            <a:ln w="22225" cap="rnd">
              <a:solidFill>
                <a:schemeClr val="accent2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D$2:$D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83999999999995</c:v>
                </c:pt>
                <c:pt idx="3">
                  <c:v>0.99983999999999995</c:v>
                </c:pt>
                <c:pt idx="4">
                  <c:v>0.99794000000000005</c:v>
                </c:pt>
                <c:pt idx="5">
                  <c:v>0.99794000000000005</c:v>
                </c:pt>
                <c:pt idx="6">
                  <c:v>0.99234</c:v>
                </c:pt>
                <c:pt idx="7">
                  <c:v>0.99234</c:v>
                </c:pt>
                <c:pt idx="8">
                  <c:v>0.98277999999999999</c:v>
                </c:pt>
                <c:pt idx="9">
                  <c:v>0.98277999999999999</c:v>
                </c:pt>
                <c:pt idx="10">
                  <c:v>0.96931999999999996</c:v>
                </c:pt>
                <c:pt idx="11">
                  <c:v>0.96931999999999996</c:v>
                </c:pt>
                <c:pt idx="12">
                  <c:v>0.95421999999999996</c:v>
                </c:pt>
                <c:pt idx="13">
                  <c:v>0.95421999999999996</c:v>
                </c:pt>
                <c:pt idx="14">
                  <c:v>0.93555999999999995</c:v>
                </c:pt>
                <c:pt idx="15">
                  <c:v>0.93555999999999995</c:v>
                </c:pt>
                <c:pt idx="16">
                  <c:v>0.91513999999999995</c:v>
                </c:pt>
                <c:pt idx="17">
                  <c:v>0.91513999999999995</c:v>
                </c:pt>
                <c:pt idx="18">
                  <c:v>0.89412000000000003</c:v>
                </c:pt>
                <c:pt idx="19">
                  <c:v>0.89412000000000003</c:v>
                </c:pt>
                <c:pt idx="20">
                  <c:v>0.87368000000000001</c:v>
                </c:pt>
                <c:pt idx="21">
                  <c:v>0.87368000000000001</c:v>
                </c:pt>
                <c:pt idx="22">
                  <c:v>0.85028000000000004</c:v>
                </c:pt>
                <c:pt idx="23">
                  <c:v>0.85028000000000004</c:v>
                </c:pt>
                <c:pt idx="24">
                  <c:v>0.82457999999999998</c:v>
                </c:pt>
                <c:pt idx="25">
                  <c:v>0.82457999999999998</c:v>
                </c:pt>
                <c:pt idx="26">
                  <c:v>0.80820999999999998</c:v>
                </c:pt>
                <c:pt idx="27">
                  <c:v>0.80820999999999998</c:v>
                </c:pt>
                <c:pt idx="28">
                  <c:v>0.7922400000000000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B9B-431D-B932-66B0E66CA879}"/>
            </c:ext>
          </c:extLst>
        </c:ser>
        <c:ser>
          <c:idx val="3"/>
          <c:order val="3"/>
          <c:tx>
            <c:strRef>
              <c:f>'p201-plots'!$E$1</c:f>
              <c:strCache>
                <c:ptCount val="1"/>
                <c:pt idx="0">
                  <c:v>Age at BC 70-79 [p=0.003 compared to comparisons age 70-79]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E$2:$E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56999999999996</c:v>
                </c:pt>
                <c:pt idx="3">
                  <c:v>0.99956999999999996</c:v>
                </c:pt>
                <c:pt idx="4">
                  <c:v>0.99678999999999995</c:v>
                </c:pt>
                <c:pt idx="5">
                  <c:v>0.99678999999999995</c:v>
                </c:pt>
                <c:pt idx="6">
                  <c:v>0.98919999999999997</c:v>
                </c:pt>
                <c:pt idx="7">
                  <c:v>0.98919999999999997</c:v>
                </c:pt>
                <c:pt idx="8">
                  <c:v>0.97660999999999998</c:v>
                </c:pt>
                <c:pt idx="9">
                  <c:v>0.97660999999999998</c:v>
                </c:pt>
                <c:pt idx="10">
                  <c:v>0.95914999999999995</c:v>
                </c:pt>
                <c:pt idx="11">
                  <c:v>0.95914999999999995</c:v>
                </c:pt>
                <c:pt idx="12">
                  <c:v>0.93976000000000004</c:v>
                </c:pt>
                <c:pt idx="13">
                  <c:v>0.93976000000000004</c:v>
                </c:pt>
                <c:pt idx="14">
                  <c:v>0.91598999999999997</c:v>
                </c:pt>
                <c:pt idx="15">
                  <c:v>0.91598999999999997</c:v>
                </c:pt>
                <c:pt idx="16">
                  <c:v>0.89017000000000002</c:v>
                </c:pt>
                <c:pt idx="17">
                  <c:v>0.89017000000000002</c:v>
                </c:pt>
                <c:pt idx="18">
                  <c:v>0.86382000000000003</c:v>
                </c:pt>
                <c:pt idx="19">
                  <c:v>0.86382000000000003</c:v>
                </c:pt>
                <c:pt idx="20">
                  <c:v>0.83828999999999998</c:v>
                </c:pt>
                <c:pt idx="21">
                  <c:v>0.83828999999999998</c:v>
                </c:pt>
                <c:pt idx="22">
                  <c:v>0.80905000000000005</c:v>
                </c:pt>
                <c:pt idx="23">
                  <c:v>0.80905000000000005</c:v>
                </c:pt>
                <c:pt idx="24">
                  <c:v>0.77656000000000003</c:v>
                </c:pt>
                <c:pt idx="25">
                  <c:v>0.77656000000000003</c:v>
                </c:pt>
                <c:pt idx="26">
                  <c:v>0.75422999999999996</c:v>
                </c:pt>
                <c:pt idx="27">
                  <c:v>0.75422999999999996</c:v>
                </c:pt>
                <c:pt idx="28">
                  <c:v>0.72377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B9B-431D-B932-66B0E66CA879}"/>
            </c:ext>
          </c:extLst>
        </c:ser>
        <c:ser>
          <c:idx val="4"/>
          <c:order val="4"/>
          <c:tx>
            <c:strRef>
              <c:f>'p201-plots'!$F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F$2:$F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34000000000001</c:v>
                </c:pt>
                <c:pt idx="3">
                  <c:v>0.99934000000000001</c:v>
                </c:pt>
                <c:pt idx="4">
                  <c:v>0.99604000000000004</c:v>
                </c:pt>
                <c:pt idx="5">
                  <c:v>0.99604000000000004</c:v>
                </c:pt>
                <c:pt idx="6">
                  <c:v>0.98740000000000006</c:v>
                </c:pt>
                <c:pt idx="7">
                  <c:v>0.98740000000000006</c:v>
                </c:pt>
                <c:pt idx="8">
                  <c:v>0.97316000000000003</c:v>
                </c:pt>
                <c:pt idx="9">
                  <c:v>0.97316000000000003</c:v>
                </c:pt>
                <c:pt idx="10">
                  <c:v>0.95347999999999999</c:v>
                </c:pt>
                <c:pt idx="11">
                  <c:v>0.95347999999999999</c:v>
                </c:pt>
                <c:pt idx="12">
                  <c:v>0.93169000000000002</c:v>
                </c:pt>
                <c:pt idx="13">
                  <c:v>0.93169000000000002</c:v>
                </c:pt>
                <c:pt idx="14">
                  <c:v>0.90505000000000002</c:v>
                </c:pt>
                <c:pt idx="15">
                  <c:v>0.90505000000000002</c:v>
                </c:pt>
                <c:pt idx="16">
                  <c:v>0.87619999999999998</c:v>
                </c:pt>
                <c:pt idx="17">
                  <c:v>0.87619999999999998</c:v>
                </c:pt>
                <c:pt idx="18">
                  <c:v>0.84684999999999999</c:v>
                </c:pt>
                <c:pt idx="19">
                  <c:v>0.84684999999999999</c:v>
                </c:pt>
                <c:pt idx="20">
                  <c:v>0.81854000000000005</c:v>
                </c:pt>
                <c:pt idx="21">
                  <c:v>0.81854000000000005</c:v>
                </c:pt>
                <c:pt idx="22">
                  <c:v>0.78622000000000003</c:v>
                </c:pt>
                <c:pt idx="23">
                  <c:v>0.78622000000000003</c:v>
                </c:pt>
                <c:pt idx="24">
                  <c:v>0.75043000000000004</c:v>
                </c:pt>
                <c:pt idx="25">
                  <c:v>0.75043000000000004</c:v>
                </c:pt>
                <c:pt idx="26">
                  <c:v>0.72567000000000004</c:v>
                </c:pt>
                <c:pt idx="27">
                  <c:v>0.72567000000000004</c:v>
                </c:pt>
                <c:pt idx="28">
                  <c:v>0.689529999999999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3B9B-431D-B932-66B0E66CA879}"/>
            </c:ext>
          </c:extLst>
        </c:ser>
        <c:ser>
          <c:idx val="5"/>
          <c:order val="5"/>
          <c:tx>
            <c:strRef>
              <c:f>'p201-plots'!$G$1</c:f>
              <c:strCache>
                <c:ptCount val="1"/>
              </c:strCache>
            </c:strRef>
          </c:tx>
          <c:spPr>
            <a:ln w="22225" cap="rnd">
              <a:solidFill>
                <a:schemeClr val="accent1">
                  <a:lumMod val="75000"/>
                </a:schemeClr>
              </a:solidFill>
              <a:prstDash val="sysDash"/>
              <a:round/>
            </a:ln>
            <a:effectLst/>
          </c:spPr>
          <c:marker>
            <c:symbol val="none"/>
          </c:marker>
          <c:xVal>
            <c:numRef>
              <c:f>'p201-plots'!$A$2:$A$30</c:f>
              <c:numCache>
                <c:formatCode>General</c:formatCode>
                <c:ptCount val="2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4</c:v>
                </c:pt>
                <c:pt idx="9">
                  <c:v>5</c:v>
                </c:pt>
                <c:pt idx="10">
                  <c:v>5</c:v>
                </c:pt>
                <c:pt idx="11">
                  <c:v>6</c:v>
                </c:pt>
                <c:pt idx="12">
                  <c:v>6</c:v>
                </c:pt>
                <c:pt idx="13">
                  <c:v>7</c:v>
                </c:pt>
                <c:pt idx="14">
                  <c:v>7</c:v>
                </c:pt>
                <c:pt idx="15">
                  <c:v>8</c:v>
                </c:pt>
                <c:pt idx="16">
                  <c:v>8</c:v>
                </c:pt>
                <c:pt idx="17">
                  <c:v>9</c:v>
                </c:pt>
                <c:pt idx="18">
                  <c:v>9</c:v>
                </c:pt>
                <c:pt idx="19">
                  <c:v>10</c:v>
                </c:pt>
                <c:pt idx="20">
                  <c:v>10</c:v>
                </c:pt>
                <c:pt idx="21">
                  <c:v>11</c:v>
                </c:pt>
                <c:pt idx="22">
                  <c:v>11</c:v>
                </c:pt>
                <c:pt idx="23">
                  <c:v>12</c:v>
                </c:pt>
                <c:pt idx="24">
                  <c:v>12</c:v>
                </c:pt>
                <c:pt idx="25">
                  <c:v>13</c:v>
                </c:pt>
                <c:pt idx="26">
                  <c:v>13</c:v>
                </c:pt>
                <c:pt idx="27">
                  <c:v>14</c:v>
                </c:pt>
                <c:pt idx="28">
                  <c:v>14</c:v>
                </c:pt>
              </c:numCache>
            </c:numRef>
          </c:xVal>
          <c:yVal>
            <c:numRef>
              <c:f>'p201-plots'!$G$2:$G$30</c:f>
              <c:numCache>
                <c:formatCode>General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9980000000000002</c:v>
                </c:pt>
                <c:pt idx="3">
                  <c:v>0.99980000000000002</c:v>
                </c:pt>
                <c:pt idx="4">
                  <c:v>0.99753000000000003</c:v>
                </c:pt>
                <c:pt idx="5">
                  <c:v>0.99753000000000003</c:v>
                </c:pt>
                <c:pt idx="6">
                  <c:v>0.99100999999999995</c:v>
                </c:pt>
                <c:pt idx="7">
                  <c:v>0.99100999999999995</c:v>
                </c:pt>
                <c:pt idx="8">
                  <c:v>0.98006000000000004</c:v>
                </c:pt>
                <c:pt idx="9">
                  <c:v>0.98006000000000004</c:v>
                </c:pt>
                <c:pt idx="10">
                  <c:v>0.96484000000000003</c:v>
                </c:pt>
                <c:pt idx="11">
                  <c:v>0.96484000000000003</c:v>
                </c:pt>
                <c:pt idx="12">
                  <c:v>0.94789000000000001</c:v>
                </c:pt>
                <c:pt idx="13">
                  <c:v>0.94789000000000001</c:v>
                </c:pt>
                <c:pt idx="14">
                  <c:v>0.92706</c:v>
                </c:pt>
                <c:pt idx="15">
                  <c:v>0.92706</c:v>
                </c:pt>
                <c:pt idx="16">
                  <c:v>0.90437000000000001</c:v>
                </c:pt>
                <c:pt idx="17">
                  <c:v>0.90437000000000001</c:v>
                </c:pt>
                <c:pt idx="18">
                  <c:v>0.88112000000000001</c:v>
                </c:pt>
                <c:pt idx="19">
                  <c:v>0.88112000000000001</c:v>
                </c:pt>
                <c:pt idx="20">
                  <c:v>0.85851999999999995</c:v>
                </c:pt>
                <c:pt idx="21">
                  <c:v>0.85851999999999995</c:v>
                </c:pt>
                <c:pt idx="22">
                  <c:v>0.83255000000000001</c:v>
                </c:pt>
                <c:pt idx="23">
                  <c:v>0.83255000000000001</c:v>
                </c:pt>
                <c:pt idx="24">
                  <c:v>0.80361000000000005</c:v>
                </c:pt>
                <c:pt idx="25">
                  <c:v>0.80361000000000005</c:v>
                </c:pt>
                <c:pt idx="26">
                  <c:v>0.78390000000000004</c:v>
                </c:pt>
                <c:pt idx="27">
                  <c:v>0.78390000000000004</c:v>
                </c:pt>
                <c:pt idx="28">
                  <c:v>0.759730000000000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3B9B-431D-B932-66B0E66CA8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1809856"/>
        <c:axId val="141810432"/>
      </c:scatterChart>
      <c:valAx>
        <c:axId val="141809856"/>
        <c:scaling>
          <c:orientation val="minMax"/>
          <c:max val="14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/>
                  <a:t>Follow Up</a:t>
                </a:r>
                <a:r>
                  <a:rPr lang="en-US" sz="1200" baseline="0"/>
                  <a:t> Years</a:t>
                </a:r>
                <a:endParaRPr 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810432"/>
        <c:crosses val="autoZero"/>
        <c:crossBetween val="midCat"/>
      </c:valAx>
      <c:valAx>
        <c:axId val="141810432"/>
        <c:scaling>
          <c:orientation val="minMax"/>
          <c:max val="1"/>
          <c:min val="0.70000000000000007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1809856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legend>
      <c:legendPos val="b"/>
      <c:legendEntry>
        <c:idx val="1"/>
        <c:delete val="1"/>
      </c:legendEntry>
      <c:legendEntry>
        <c:idx val="2"/>
        <c:delete val="1"/>
      </c:legendEntry>
      <c:legendEntry>
        <c:idx val="4"/>
        <c:delete val="1"/>
      </c:legendEntry>
      <c:legendEntry>
        <c:idx val="5"/>
        <c:delete val="1"/>
      </c:legendEntry>
      <c:layout>
        <c:manualLayout>
          <c:xMode val="edge"/>
          <c:yMode val="edge"/>
          <c:x val="0.13261238036584147"/>
          <c:y val="0.59613797345602104"/>
          <c:w val="0.5847765748031496"/>
          <c:h val="0.160391121983674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049</cdr:x>
      <cdr:y>0.6388</cdr:y>
    </cdr:from>
    <cdr:to>
      <cdr:x>0.74679</cdr:x>
      <cdr:y>0.8181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2A46E6F5-4D14-4231-A938-3E0F2669858D}"/>
            </a:ext>
          </a:extLst>
        </cdr:cNvPr>
        <cdr:cNvSpPr txBox="1"/>
      </cdr:nvSpPr>
      <cdr:spPr>
        <a:xfrm xmlns:a="http://schemas.openxmlformats.org/drawingml/2006/main">
          <a:off x="4956968" y="325675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000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244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499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507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0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762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800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810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933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786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760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98FE1-CDC2-4BF5-B56F-605D2498FDA3}" type="datetimeFigureOut">
              <a:rPr lang="en-US" smtClean="0"/>
              <a:t>6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6AC87-DC2B-4935-87AB-DDF182F80E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034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a16="http://schemas.microsoft.com/office/drawing/2014/main" xmlns="" xmlns:xdr="http://schemas.openxmlformats.org/drawingml/2006/spreadsheetDrawing" xmlns:w="http://schemas.openxmlformats.org/wordprocessingml/2006/main" xmlns:w10="urn:schemas-microsoft-com:office:word" xmlns:v="urn:schemas-microsoft-com:vml" xmlns:o="urn:schemas-microsoft-com:office:office" xmlns:lc="http://schemas.openxmlformats.org/drawingml/2006/lockedCanvas" id="{00000000-0008-0000-6A00-000002000000}"/>
              </a:ext>
            </a:extLst>
          </p:cNvPr>
          <p:cNvGraphicFramePr/>
          <p:nvPr/>
        </p:nvGraphicFramePr>
        <p:xfrm>
          <a:off x="1016000" y="1346200"/>
          <a:ext cx="7112000" cy="416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13681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jpark68</dc:creator>
  <cp:lastModifiedBy>njpark68</cp:lastModifiedBy>
  <cp:revision>1</cp:revision>
  <dcterms:created xsi:type="dcterms:W3CDTF">2017-06-22T09:04:12Z</dcterms:created>
  <dcterms:modified xsi:type="dcterms:W3CDTF">2017-06-22T09:05:53Z</dcterms:modified>
</cp:coreProperties>
</file>